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FCE407D-9E83-4D7E-A03A-BD4E4490BC3C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905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D0B4EA3-84F3-4211-BEC0-82C51A611B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174016D-FD5E-4419-B557-3285382139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948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905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8FBCD64-0DA2-46E7-9E5C-6BE06CE29BC5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47E80BD-F4D7-44E5-8D9E-00755A6A9B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70C3A5F-467C-486F-8D96-56B5AF9CE0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3AB0689-1561-444D-8DE6-D794A50734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DBBDE8-78F1-4891-933D-A6B3CC1164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5040"/>
            <a:ext cx="6170400" cy="7073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D5CC977-B07D-4B3E-8F84-9AE30B08BB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48209DA-AF31-42AF-A960-EB18A7F385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905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A0A9256-C74B-421E-8745-E0B190E8CA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948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905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4979216-0156-46D2-AEB7-F86B888601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4/4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E6E197CE-66A0-4D2E-A9BF-28D470BC1C06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70400" cy="15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343080" y="213948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25520" y="179280"/>
            <a:ext cx="5376960" cy="4030920"/>
            <a:chOff x="425520" y="179280"/>
            <a:chExt cx="5376960" cy="40309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0" t="0" r="25454" b="0"/>
            <a:stretch/>
          </p:blipFill>
          <p:spPr>
            <a:xfrm>
              <a:off x="692280" y="450720"/>
              <a:ext cx="5110200" cy="375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425520" y="179280"/>
              <a:ext cx="3894480" cy="272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2171880"/>
                  <a:tab algn="l" pos="2895480"/>
                  <a:tab algn="l" pos="361944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.  Glabrous cotyledons of hairy leaf AtGL3+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B. napu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489960" y="4295880"/>
            <a:ext cx="5313600" cy="3947760"/>
            <a:chOff x="489960" y="4295880"/>
            <a:chExt cx="5313600" cy="3947760"/>
          </a:xfrm>
        </p:grpSpPr>
        <p:pic>
          <p:nvPicPr>
            <p:cNvPr id="45" name="" descr=""/>
            <p:cNvPicPr/>
            <p:nvPr/>
          </p:nvPicPr>
          <p:blipFill>
            <a:blip r:embed="rId2"/>
            <a:srcRect l="0" t="0" r="25664" b="0"/>
            <a:stretch/>
          </p:blipFill>
          <p:spPr>
            <a:xfrm>
              <a:off x="706320" y="4514760"/>
              <a:ext cx="5097240" cy="372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489960" y="4295880"/>
              <a:ext cx="3394800" cy="272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2171880"/>
                  <a:tab algn="l" pos="289548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.  Glabrous cotyledons of ultra hairy leaf K-5-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"/>
          <p:cNvSpPr/>
          <p:nvPr/>
        </p:nvSpPr>
        <p:spPr>
          <a:xfrm>
            <a:off x="0" y="8205840"/>
            <a:ext cx="6858000" cy="82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S4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MAPMAN heat maps of metabolism genes in glabrous cotyledons of (A) hairy leaf AtGL3+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B. napus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d (B) ultra-hairy leaf K-5-8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B. napus,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elative to Westar. Maps show numbers of ESTs and expression intensity. Blue blocks represent up-regulated genes. Red blocks represent individual down-regulated genes. Relative expression intensity scale is in log2, where ±5 represents ±log25 or greate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